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974" y="-2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615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6916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1898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3080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9080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4145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5157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4994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195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8744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1075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3327F-2687-4D94-9A72-105F29DB6F32}" type="datetimeFigureOut">
              <a:rPr lang="es-ES" smtClean="0"/>
              <a:t>18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64B4B-9E2C-419E-8FA6-8D1F7AFDD0E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232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3616" y="106155"/>
            <a:ext cx="6667043" cy="5299563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365770" y="5405718"/>
            <a:ext cx="852273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</a:t>
            </a:r>
            <a:r>
              <a:rPr lang="en-US" sz="11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unctional effects of STIM/</a:t>
            </a:r>
            <a:r>
              <a:rPr lang="en-US" sz="11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ai</a:t>
            </a:r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hibition on aging-related </a:t>
            </a:r>
            <a:r>
              <a:rPr lang="en-US" sz="11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percontractility</a:t>
            </a:r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s not dependent on gender and is not related to diabetes or hypertension.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ffects of </a:t>
            </a:r>
            <a:r>
              <a:rPr lang="en-US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ai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annel inhibition with YM-58483 (20 µM) on norepinephrine (NE)-induced contraction in human mesenteric arteries (MA) (A) and human aortic strips (B) obtained from female organ donors &gt;65 years old.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ower panels show the inhibitory effect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</a:t>
            </a:r>
            <a:r>
              <a:rPr lang="en-US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ai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annel inhibition with YM-58483 (20 µM) on NE-induced contractions in human MA from organ donors &gt;65 years old without diabetes (C) and without hypertension (D).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ata are expressed as mean ± SEM of the percentage of contraction induced by 125 </a:t>
            </a:r>
            <a:r>
              <a:rPr lang="en-US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K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efore addition of YM-58483 or the vehicle (0.2% DMSO). n indicates the number of subjects. ***p &lt;0.001 vs respective responses without YM-58483 by 2-factor ANOVA.</a:t>
            </a:r>
            <a:endParaRPr lang="es-ES" sz="1100" dirty="0"/>
          </a:p>
        </p:txBody>
      </p:sp>
    </p:spTree>
    <p:extLst>
      <p:ext uri="{BB962C8B-B14F-4D97-AF65-F5344CB8AC3E}">
        <p14:creationId xmlns:p14="http://schemas.microsoft.com/office/powerpoint/2010/main" val="22881944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16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F</dc:creator>
  <cp:lastModifiedBy>MDPI</cp:lastModifiedBy>
  <cp:revision>5</cp:revision>
  <dcterms:created xsi:type="dcterms:W3CDTF">2022-11-05T19:42:30Z</dcterms:created>
  <dcterms:modified xsi:type="dcterms:W3CDTF">2022-11-18T14:29:47Z</dcterms:modified>
</cp:coreProperties>
</file>